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66760" y="1240920"/>
            <a:ext cx="4464000" cy="334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EAF2D5-D34A-4570-836C-69B21F0DC24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ldImg"/>
          </p:nvPr>
        </p:nvSpPr>
        <p:spPr>
          <a:xfrm>
            <a:off x="1166760" y="1241280"/>
            <a:ext cx="4464000" cy="3349800"/>
          </a:xfrm>
          <a:prstGeom prst="rect">
            <a:avLst/>
          </a:prstGeom>
          <a:ln w="0">
            <a:noFill/>
          </a:ln>
        </p:spPr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スライド番号プレースホルダー 3"/>
          <p:cNvSpPr/>
          <p:nvPr/>
        </p:nvSpPr>
        <p:spPr>
          <a:xfrm>
            <a:off x="3849840" y="9428040"/>
            <a:ext cx="29462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41A491-08A8-4415-814A-628B3BABA0F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642E8-BEC5-4E73-8778-4E1647F4CA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C91BE-3867-4B15-9307-7EAB2402B3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EE93C-28D0-421B-8550-DF5329F4FC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370E0-A915-4639-93E8-C0AC10F7F0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404FE-BE41-4868-B020-199556FAD5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D118E-3913-4417-A038-AFAB0EAFF6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A4B7C-17F7-4F95-9B9F-5B68694CCB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E0AF7-8795-41AD-9357-AEFD330109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B7806-3207-4837-AE89-97AC81D9A9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A7AC4-3240-4C4D-AEFE-690F54B004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516D2-1010-4429-ACE6-7260EBEF3F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6088A3-8819-4D4E-9A85-5BBDC710F8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733525-D199-477D-82AC-1D1758A9695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2" descr=""/>
          <p:cNvPicPr/>
          <p:nvPr/>
        </p:nvPicPr>
        <p:blipFill>
          <a:blip r:embed="rId1"/>
          <a:stretch/>
        </p:blipFill>
        <p:spPr>
          <a:xfrm>
            <a:off x="1668600" y="-9360"/>
            <a:ext cx="5924520" cy="577368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10"/>
          <p:cNvSpPr/>
          <p:nvPr/>
        </p:nvSpPr>
        <p:spPr>
          <a:xfrm>
            <a:off x="2282760" y="549360"/>
            <a:ext cx="117000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Hb (g/d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25"/>
          <p:cNvSpPr/>
          <p:nvPr/>
        </p:nvSpPr>
        <p:spPr>
          <a:xfrm>
            <a:off x="3540240" y="1893960"/>
            <a:ext cx="119988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T (IU/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26"/>
          <p:cNvSpPr/>
          <p:nvPr/>
        </p:nvSpPr>
        <p:spPr>
          <a:xfrm>
            <a:off x="4913280" y="3208320"/>
            <a:ext cx="120168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LT (IU/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27"/>
          <p:cNvSpPr/>
          <p:nvPr/>
        </p:nvSpPr>
        <p:spPr>
          <a:xfrm>
            <a:off x="6188040" y="4525920"/>
            <a:ext cx="123516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Times New Roman"/>
              </a:rPr>
              <a:t>γ-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GTP (IU/L)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正方形/長方形 12"/>
          <p:cNvSpPr/>
          <p:nvPr/>
        </p:nvSpPr>
        <p:spPr>
          <a:xfrm>
            <a:off x="4025160" y="21096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0.05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52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正方形/長方形 31"/>
          <p:cNvSpPr/>
          <p:nvPr/>
        </p:nvSpPr>
        <p:spPr>
          <a:xfrm>
            <a:off x="5324400" y="21096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0.172</a:t>
            </a:r>
            <a:br>
              <a:rPr sz="1100"/>
            </a:b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051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正方形/長方形 32"/>
          <p:cNvSpPr/>
          <p:nvPr/>
        </p:nvSpPr>
        <p:spPr>
          <a:xfrm>
            <a:off x="6657840" y="210960"/>
            <a:ext cx="81000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- 0.116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191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正方形/長方形 33"/>
          <p:cNvSpPr/>
          <p:nvPr/>
        </p:nvSpPr>
        <p:spPr>
          <a:xfrm>
            <a:off x="5033160" y="168120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751</a:t>
            </a:r>
            <a:br>
              <a:rPr sz="1100"/>
            </a:b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正方形/長方形 34"/>
          <p:cNvSpPr/>
          <p:nvPr/>
        </p:nvSpPr>
        <p:spPr>
          <a:xfrm>
            <a:off x="6658560" y="299412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423</a:t>
            </a:r>
            <a:br>
              <a:rPr sz="1100"/>
            </a:b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正方形/長方形 35"/>
          <p:cNvSpPr/>
          <p:nvPr/>
        </p:nvSpPr>
        <p:spPr>
          <a:xfrm>
            <a:off x="6633360" y="1611360"/>
            <a:ext cx="74304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257 </a:t>
            </a:r>
            <a:br>
              <a:rPr sz="1100"/>
            </a:b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正方形/長方形 39"/>
          <p:cNvSpPr/>
          <p:nvPr/>
        </p:nvSpPr>
        <p:spPr>
          <a:xfrm>
            <a:off x="2187720" y="2789280"/>
            <a:ext cx="1265040" cy="128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正方形/長方形 41"/>
          <p:cNvSpPr/>
          <p:nvPr/>
        </p:nvSpPr>
        <p:spPr>
          <a:xfrm>
            <a:off x="3532320" y="2789280"/>
            <a:ext cx="1265040" cy="128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3"/>
          <p:cNvSpPr/>
          <p:nvPr/>
        </p:nvSpPr>
        <p:spPr>
          <a:xfrm>
            <a:off x="-17640" y="5538960"/>
            <a:ext cx="9161640" cy="12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</a:t>
            </a: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4 Correlation between liver function test value post-operative day (POD) 7 and hemoglobin at POD7</a:t>
            </a:r>
            <a:br>
              <a:rPr sz="16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nificant correlation was not observed between hemoglobin level POD7 and liver function tests POD7, such as aspartate aminotransferase, alanine aminotransferase and gamma-glutamyl transferase. Statistical analysis were performed using Pearson correlation coefficient. The red ellipse represents 95% confidence interv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10T02:56:22Z</dcterms:created>
  <dc:creator>近藤悠希【Yuki KONDO】</dc:creator>
  <dc:description/>
  <dc:language>en-US</dc:language>
  <cp:lastModifiedBy>近藤悠希【Yuki KONDO】</cp:lastModifiedBy>
  <cp:lastPrinted>2016-08-08T11:36:20Z</cp:lastPrinted>
  <dcterms:modified xsi:type="dcterms:W3CDTF">2017-01-13T11:43:10Z</dcterms:modified>
  <cp:revision>66</cp:revision>
  <dc:subject/>
  <dc:title>PowerPoint プレゼンテーション</dc:title>
</cp:coreProperties>
</file>